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  <p:sldId id="28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6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5206B0-87C8-4814-95A4-9B53B5E8F5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F502AD-CD08-4967-83B8-72C47823B1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442527-7218-4B21-AC6F-390BA4E98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E33FFB-F279-4811-A257-2DBB5E8D9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A8589C-5C55-4696-9506-7F9D4B25A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212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5CE75C-580E-4E1C-8FAB-4F84F9E84B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6A61A0-1690-444A-B976-0B7F78CC11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922C77-C6D5-4241-9DBA-03F0AAFF6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0DF74B-A08C-4172-B75A-750FEAB083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36A878-C9B5-469B-91DC-AF50E0DB0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768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510A5B1-0FFC-4520-BC16-F7F89EB41A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A7FA10-1579-4F52-98C8-3D71138AA5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770941-5699-49B1-918C-B5A594B5C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0E3683-B99D-4676-B93E-1237BB67C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8B2602-CD62-4BEE-A618-4F56B2A596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679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FAD077-CFB0-41CF-A6AE-193D3EAAFD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83D2D1-F5F7-4335-95FC-4DB0E70D5F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80FA1C-50BD-4A97-8C5A-2CAB7BC466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035908-BC05-4863-88FA-2D909A69B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D060F0-C049-4880-95AF-7BFE3BD3E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34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38EC32-1435-45C9-863A-3E00593D14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F06CE5-33B7-4BED-81D0-A691F584E4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CF5C2F-7BB6-40C0-9FCA-899ADA3A9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CA1F9F-253A-42CB-A429-B4DA85671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839829-1341-4A13-9C6B-F4891082AF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77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37A508-6E98-4467-8743-B1B9EBE787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D4A4F9-0BC9-4F95-8F46-486541A0E8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81DC7F-EEEB-4BC5-B9A7-41307F7E41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53E2DE-42AB-4B6B-A491-FED2701F0D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51FD23-6A04-4610-98E9-60D6B9F4D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59329D-A6B4-4658-94C5-2BCD4A41E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28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72837C-87C3-427D-9ED1-63122A538C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B9019E-FA85-482C-A883-4532AB0156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C97B37-1F4C-4344-A492-2A26D2CB04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C0AD53-BB50-473B-A66F-FDCFF205DC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9530B9-0DD9-4FF2-B35D-CF7439DD3D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B79743-E21F-47A3-B7C4-4E65D5B95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A9C714-BC98-4913-927D-245F49897B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9B1E12D-3CC4-45B9-8F5D-19CAE539F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975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2D35E6-215A-473E-8AC7-3F62F27DF1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67DF601-EB19-4037-BB8F-EFBDC9D34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559332-0F18-4773-A3D2-CC81FBB1D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F26D09-D99C-46C8-ABE1-3852FE9FE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561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1F19FAA-AB97-4ECD-9076-84A2B070A5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7AD2403-B3A1-4CE6-9593-96E87F91EE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63AA2A-7DEF-4D1F-8889-2B723C592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399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2E0676-4F0E-4450-91F3-FEC76E974E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185B02-B656-42F3-89A4-A6262D6DC9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511934-CEF1-407F-9D06-0F6FFE29CA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C13C22-B8E4-4C95-8A74-6F19D13F58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4FF6DC-DB1F-4D61-8A9B-3E9F6310C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AA052E-FF06-43CD-A71E-350EFDE98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283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8A282-CF68-40F3-9621-46305AD8BD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499FD31-04CC-4A0A-9103-A3493B1A5A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6F9BC6-F425-465B-8466-D03460BC2E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94D99E-9BFD-42F7-92AD-3CA4931DF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AE23AB-03A1-4D66-A83A-F434AC976B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7D7DE7-F735-48B6-87E4-BC236BB0E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048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982D68-0DB1-402E-B2CC-BD1914609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5A3F61-D50C-4379-AE45-45BB76425B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7327A9-0324-46DA-BA1C-D3702D3B61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708C3B-98FB-48E4-AAAF-10394D94A684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F710BB-3056-450A-AF7B-D6207B327D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210355-43F3-4DD1-8E94-C1741FD885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7C55C7-83D1-41F7-B34C-55253304F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400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7B4673F-357D-4FA2-8F90-F12F2AAA68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7312" y="119075"/>
            <a:ext cx="9544038" cy="615178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AB8AC5F-FBC6-432B-9364-C834826BB771}"/>
              </a:ext>
            </a:extLst>
          </p:cNvPr>
          <p:cNvSpPr txBox="1"/>
          <p:nvPr/>
        </p:nvSpPr>
        <p:spPr>
          <a:xfrm>
            <a:off x="2408931" y="6508093"/>
            <a:ext cx="86821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Palatino Linotype" panose="02040502050505030304" pitchFamily="18" charset="0"/>
              </a:rPr>
              <a:t>Supplementary Figure S1A.</a:t>
            </a:r>
            <a:r>
              <a:rPr lang="en-US" sz="900" dirty="0">
                <a:latin typeface="Palatino Linotype" panose="02040502050505030304" pitchFamily="18" charset="0"/>
              </a:rPr>
              <a:t> Downregulated DEGs in 6H BTEE-treated condition related to ‘cytokine-cytokine receptor interaction’ KEGG pathway (Red marked genes)</a:t>
            </a:r>
          </a:p>
        </p:txBody>
      </p:sp>
    </p:spTree>
    <p:extLst>
      <p:ext uri="{BB962C8B-B14F-4D97-AF65-F5344CB8AC3E}">
        <p14:creationId xmlns:p14="http://schemas.microsoft.com/office/powerpoint/2010/main" val="19774173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KEGG pathway image.">
            <a:extLst>
              <a:ext uri="{FF2B5EF4-FFF2-40B4-BE49-F238E27FC236}">
                <a16:creationId xmlns:a16="http://schemas.microsoft.com/office/drawing/2014/main" id="{A897A865-126E-4629-9562-594E612C37E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0504" y="139148"/>
            <a:ext cx="9408009" cy="60642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6F98165-AD19-455A-BADC-8A6A5DEF04A1}"/>
              </a:ext>
            </a:extLst>
          </p:cNvPr>
          <p:cNvSpPr txBox="1"/>
          <p:nvPr/>
        </p:nvSpPr>
        <p:spPr>
          <a:xfrm>
            <a:off x="2408931" y="6508093"/>
            <a:ext cx="87943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Palatino Linotype" panose="02040502050505030304" pitchFamily="18" charset="0"/>
              </a:rPr>
              <a:t>Supplementary Figure S1B.</a:t>
            </a:r>
            <a:r>
              <a:rPr lang="en-US" sz="900" dirty="0">
                <a:latin typeface="Palatino Linotype" panose="02040502050505030304" pitchFamily="18" charset="0"/>
              </a:rPr>
              <a:t> Downregulated DEGs in 17H BTEE-treated condition related to ‘cytokine-cytokine receptor interaction’ KEGG pathway (Red marked genes).</a:t>
            </a:r>
          </a:p>
        </p:txBody>
      </p:sp>
    </p:spTree>
    <p:extLst>
      <p:ext uri="{BB962C8B-B14F-4D97-AF65-F5344CB8AC3E}">
        <p14:creationId xmlns:p14="http://schemas.microsoft.com/office/powerpoint/2010/main" val="779882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8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rdousi Farhana</dc:creator>
  <cp:lastModifiedBy>MDPI</cp:lastModifiedBy>
  <cp:revision>3</cp:revision>
  <dcterms:created xsi:type="dcterms:W3CDTF">2023-02-11T17:15:00Z</dcterms:created>
  <dcterms:modified xsi:type="dcterms:W3CDTF">2023-04-03T09:20:15Z</dcterms:modified>
</cp:coreProperties>
</file>